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4" r:id="rId2"/>
  </p:sldIdLst>
  <p:sldSz cx="6858000" cy="9906000" type="A4"/>
  <p:notesSz cx="6742113" cy="98758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4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FF"/>
    <a:srgbClr val="0000FF"/>
    <a:srgbClr val="DF536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74" autoAdjust="0"/>
    <p:restoredTop sz="95765" autoAdjust="0"/>
  </p:normalViewPr>
  <p:slideViewPr>
    <p:cSldViewPr snapToGrid="0">
      <p:cViewPr varScale="1">
        <p:scale>
          <a:sx n="63" d="100"/>
          <a:sy n="63" d="100"/>
        </p:scale>
        <p:origin x="328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eetika Naudiyal" userId="4db9a0582a5adb64" providerId="LiveId" clId="{18CAEDC4-F4B8-45E8-952D-06807BE074B4}"/>
    <pc:docChg chg="modSld">
      <pc:chgData name="Neetika Naudiyal" userId="4db9a0582a5adb64" providerId="LiveId" clId="{18CAEDC4-F4B8-45E8-952D-06807BE074B4}" dt="2025-08-27T14:27:13.346" v="16"/>
      <pc:docMkLst>
        <pc:docMk/>
      </pc:docMkLst>
      <pc:sldChg chg="addSp modSp mod modCm modNotesTx">
        <pc:chgData name="Neetika Naudiyal" userId="4db9a0582a5adb64" providerId="LiveId" clId="{18CAEDC4-F4B8-45E8-952D-06807BE074B4}" dt="2025-08-27T14:27:13.346" v="16"/>
        <pc:sldMkLst>
          <pc:docMk/>
          <pc:sldMk cId="76282514" sldId="274"/>
        </pc:sldMkLst>
        <pc:spChg chg="add mod">
          <ac:chgData name="Neetika Naudiyal" userId="4db9a0582a5adb64" providerId="LiveId" clId="{18CAEDC4-F4B8-45E8-952D-06807BE074B4}" dt="2025-08-27T13:04:10.970" v="10" actId="113"/>
          <ac:spMkLst>
            <pc:docMk/>
            <pc:sldMk cId="76282514" sldId="274"/>
            <ac:spMk id="68" creationId="{1CB8BEDF-6648-CB2E-883A-ECFA2AD29AB2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100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19525" y="0"/>
            <a:ext cx="292100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CBBF36-F3FC-4E5A-BB36-7C9B1D956BC0}" type="datetimeFigureOut">
              <a:rPr lang="en-IN" smtClean="0"/>
              <a:t>26-09-2025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1235075"/>
            <a:ext cx="2306637" cy="33321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4688" y="4752975"/>
            <a:ext cx="5392737" cy="38877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80538"/>
            <a:ext cx="292100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19525" y="9380538"/>
            <a:ext cx="292100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2BCE1F-CB70-4184-92BA-7EE9D4EB663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638712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(A-D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eiver-operating characteristic curve analysis of th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osinophil proportion,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osinophil count,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ody weight, and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ody surface area associated with the occurrence of skin-related adverse events of any grade.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C2BCE1F-CB70-4184-92BA-7EE9D4EB6634}" type="slidenum">
              <a:rPr lang="en-IN" smtClean="0"/>
              <a:t>1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42503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27E42-2C55-47AA-817B-C020719D7DB9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A45CA-DF4D-498D-8FB5-3D29454F66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3914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27E42-2C55-47AA-817B-C020719D7DB9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A45CA-DF4D-498D-8FB5-3D29454F66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37255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27E42-2C55-47AA-817B-C020719D7DB9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A45CA-DF4D-498D-8FB5-3D29454F66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50187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27E42-2C55-47AA-817B-C020719D7DB9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A45CA-DF4D-498D-8FB5-3D29454F66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17099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27E42-2C55-47AA-817B-C020719D7DB9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A45CA-DF4D-498D-8FB5-3D29454F66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58783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27E42-2C55-47AA-817B-C020719D7DB9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A45CA-DF4D-498D-8FB5-3D29454F66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44774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27E42-2C55-47AA-817B-C020719D7DB9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A45CA-DF4D-498D-8FB5-3D29454F66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31207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27E42-2C55-47AA-817B-C020719D7DB9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A45CA-DF4D-498D-8FB5-3D29454F66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15667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27E42-2C55-47AA-817B-C020719D7DB9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A45CA-DF4D-498D-8FB5-3D29454F66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0895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27E42-2C55-47AA-817B-C020719D7DB9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A45CA-DF4D-498D-8FB5-3D29454F66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46944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27E42-2C55-47AA-817B-C020719D7DB9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A45CA-DF4D-498D-8FB5-3D29454F66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29295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E27E42-2C55-47AA-817B-C020719D7DB9}" type="datetimeFigureOut">
              <a:rPr kumimoji="1" lang="ja-JP" altLang="en-US" smtClean="0"/>
              <a:t>2025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CA45CA-DF4D-498D-8FB5-3D29454F66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89250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6" name="図 95">
            <a:extLst>
              <a:ext uri="{FF2B5EF4-FFF2-40B4-BE49-F238E27FC236}">
                <a16:creationId xmlns:a16="http://schemas.microsoft.com/office/drawing/2014/main" id="{5A2937C3-B314-5925-9D3A-4B7491118CD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6477" y="2795545"/>
            <a:ext cx="1620000" cy="1620000"/>
          </a:xfrm>
          <a:prstGeom prst="rect">
            <a:avLst/>
          </a:prstGeom>
        </p:spPr>
      </p:pic>
      <p:pic>
        <p:nvPicPr>
          <p:cNvPr id="95" name="図 94">
            <a:extLst>
              <a:ext uri="{FF2B5EF4-FFF2-40B4-BE49-F238E27FC236}">
                <a16:creationId xmlns:a16="http://schemas.microsoft.com/office/drawing/2014/main" id="{9026D1B4-A8BD-04EF-2632-3D69B6AAD26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23881" y="465056"/>
            <a:ext cx="1620000" cy="1620000"/>
          </a:xfrm>
          <a:prstGeom prst="rect">
            <a:avLst/>
          </a:prstGeom>
        </p:spPr>
      </p:pic>
      <p:pic>
        <p:nvPicPr>
          <p:cNvPr id="91" name="図 90">
            <a:extLst>
              <a:ext uri="{FF2B5EF4-FFF2-40B4-BE49-F238E27FC236}">
                <a16:creationId xmlns:a16="http://schemas.microsoft.com/office/drawing/2014/main" id="{75E174D3-13B6-4A72-DA09-2306F0A8F81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45289" y="465056"/>
            <a:ext cx="1620000" cy="1620000"/>
          </a:xfrm>
          <a:prstGeom prst="rect">
            <a:avLst/>
          </a:prstGeom>
        </p:spPr>
      </p:pic>
      <p:pic>
        <p:nvPicPr>
          <p:cNvPr id="90" name="図 89">
            <a:extLst>
              <a:ext uri="{FF2B5EF4-FFF2-40B4-BE49-F238E27FC236}">
                <a16:creationId xmlns:a16="http://schemas.microsoft.com/office/drawing/2014/main" id="{91D2720B-68B3-0549-BEF0-4B3389E0678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2783" y="465056"/>
            <a:ext cx="1620000" cy="1620000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FD34D2CB-5293-B525-E78A-ACF7FBC1FCEA}"/>
              </a:ext>
            </a:extLst>
          </p:cNvPr>
          <p:cNvSpPr/>
          <p:nvPr/>
        </p:nvSpPr>
        <p:spPr>
          <a:xfrm>
            <a:off x="43729" y="112510"/>
            <a:ext cx="1722867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1.</a:t>
            </a:r>
            <a:endParaRPr lang="ja-JP" altLang="en-US" sz="800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23430E3-4406-20C9-C80A-75F790D55BAA}"/>
              </a:ext>
            </a:extLst>
          </p:cNvPr>
          <p:cNvSpPr txBox="1"/>
          <p:nvPr/>
        </p:nvSpPr>
        <p:spPr>
          <a:xfrm>
            <a:off x="62376" y="281587"/>
            <a:ext cx="4068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Arial" charset="0"/>
                <a:ea typeface="Arial" charset="0"/>
                <a:cs typeface="Arial" charset="0"/>
              </a:rPr>
              <a:t>A</a:t>
            </a:r>
            <a:endParaRPr kumimoji="1" lang="ja-JP" alt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9D27F68-5E61-2E02-17C7-07BE4CF88BF5}"/>
              </a:ext>
            </a:extLst>
          </p:cNvPr>
          <p:cNvSpPr txBox="1"/>
          <p:nvPr/>
        </p:nvSpPr>
        <p:spPr>
          <a:xfrm>
            <a:off x="4601053" y="280070"/>
            <a:ext cx="4068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Arial" charset="0"/>
                <a:ea typeface="Arial" charset="0"/>
                <a:cs typeface="Arial" charset="0"/>
              </a:rPr>
              <a:t>C</a:t>
            </a:r>
            <a:endParaRPr kumimoji="1" lang="ja-JP" alt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7A0A129-3D28-F605-A54D-D2E1B1B4535D}"/>
              </a:ext>
            </a:extLst>
          </p:cNvPr>
          <p:cNvSpPr txBox="1"/>
          <p:nvPr/>
        </p:nvSpPr>
        <p:spPr>
          <a:xfrm>
            <a:off x="2281954" y="280070"/>
            <a:ext cx="4068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Arial" charset="0"/>
                <a:ea typeface="Arial" charset="0"/>
                <a:cs typeface="Arial" charset="0"/>
              </a:rPr>
              <a:t>B</a:t>
            </a:r>
            <a:endParaRPr kumimoji="1" lang="ja-JP" alt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CB205610-2823-1A6D-9694-01D0B88A419F}"/>
              </a:ext>
            </a:extLst>
          </p:cNvPr>
          <p:cNvSpPr/>
          <p:nvPr/>
        </p:nvSpPr>
        <p:spPr>
          <a:xfrm>
            <a:off x="4856009" y="355779"/>
            <a:ext cx="220840" cy="176701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30" name="Rectangle 74">
            <a:extLst>
              <a:ext uri="{FF2B5EF4-FFF2-40B4-BE49-F238E27FC236}">
                <a16:creationId xmlns:a16="http://schemas.microsoft.com/office/drawing/2014/main" id="{78D4885A-69F4-FCAE-E805-6F4612482B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32579" y="545562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1.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31" name="Rectangle 74">
            <a:extLst>
              <a:ext uri="{FF2B5EF4-FFF2-40B4-BE49-F238E27FC236}">
                <a16:creationId xmlns:a16="http://schemas.microsoft.com/office/drawing/2014/main" id="{9A9BECB4-001F-F3D5-095B-912A7CAAEA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32579" y="1040430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6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32" name="Rectangle 74">
            <a:extLst>
              <a:ext uri="{FF2B5EF4-FFF2-40B4-BE49-F238E27FC236}">
                <a16:creationId xmlns:a16="http://schemas.microsoft.com/office/drawing/2014/main" id="{120F5951-FB3D-1326-3AE5-9914BDA73B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32579" y="1287864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4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33" name="Rectangle 74">
            <a:extLst>
              <a:ext uri="{FF2B5EF4-FFF2-40B4-BE49-F238E27FC236}">
                <a16:creationId xmlns:a16="http://schemas.microsoft.com/office/drawing/2014/main" id="{A969158F-59A9-13DE-17F5-7D8A22441A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28272" y="1782730"/>
            <a:ext cx="57708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34" name="Rectangle 74">
            <a:extLst>
              <a:ext uri="{FF2B5EF4-FFF2-40B4-BE49-F238E27FC236}">
                <a16:creationId xmlns:a16="http://schemas.microsoft.com/office/drawing/2014/main" id="{2F8623F9-FFFC-BE82-A30C-A54731588B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32579" y="792996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8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35" name="Rectangle 74">
            <a:extLst>
              <a:ext uri="{FF2B5EF4-FFF2-40B4-BE49-F238E27FC236}">
                <a16:creationId xmlns:a16="http://schemas.microsoft.com/office/drawing/2014/main" id="{CB1314F7-5756-EB05-E2B1-5D19CB2C97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32579" y="1535298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2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51853EDB-331A-D45C-85ED-C7061A21A7FD}"/>
              </a:ext>
            </a:extLst>
          </p:cNvPr>
          <p:cNvSpPr txBox="1"/>
          <p:nvPr/>
        </p:nvSpPr>
        <p:spPr>
          <a:xfrm rot="16200000">
            <a:off x="4446538" y="1111136"/>
            <a:ext cx="755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Sensitivity</a:t>
            </a:r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F7F33F81-FE7C-D08E-6FC8-7029B5A9181C}"/>
              </a:ext>
            </a:extLst>
          </p:cNvPr>
          <p:cNvSpPr/>
          <p:nvPr/>
        </p:nvSpPr>
        <p:spPr>
          <a:xfrm>
            <a:off x="5101562" y="1925099"/>
            <a:ext cx="1362044" cy="1774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38" name="Rectangle 74">
            <a:extLst>
              <a:ext uri="{FF2B5EF4-FFF2-40B4-BE49-F238E27FC236}">
                <a16:creationId xmlns:a16="http://schemas.microsoft.com/office/drawing/2014/main" id="{44B36F5F-F865-36CA-C2B4-E563234F6A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87659" y="1919388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1.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39" name="Rectangle 74">
            <a:extLst>
              <a:ext uri="{FF2B5EF4-FFF2-40B4-BE49-F238E27FC236}">
                <a16:creationId xmlns:a16="http://schemas.microsoft.com/office/drawing/2014/main" id="{D6DE8FFD-614D-06CD-1D82-D8F0F90578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76257" y="1919388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6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40" name="Rectangle 74">
            <a:extLst>
              <a:ext uri="{FF2B5EF4-FFF2-40B4-BE49-F238E27FC236}">
                <a16:creationId xmlns:a16="http://schemas.microsoft.com/office/drawing/2014/main" id="{1D438BA6-39C3-F837-870B-AA4508E359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32912" y="1919388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4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41" name="Rectangle 74">
            <a:extLst>
              <a:ext uri="{FF2B5EF4-FFF2-40B4-BE49-F238E27FC236}">
                <a16:creationId xmlns:a16="http://schemas.microsoft.com/office/drawing/2014/main" id="{CA23C81A-F6BE-ACEA-F1A3-83CD49E964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0936" y="1919388"/>
            <a:ext cx="57708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42" name="Rectangle 74">
            <a:extLst>
              <a:ext uri="{FF2B5EF4-FFF2-40B4-BE49-F238E27FC236}">
                <a16:creationId xmlns:a16="http://schemas.microsoft.com/office/drawing/2014/main" id="{85155058-2300-EC3D-60BD-545538B564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44314" y="1919388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8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43" name="Rectangle 74">
            <a:extLst>
              <a:ext uri="{FF2B5EF4-FFF2-40B4-BE49-F238E27FC236}">
                <a16:creationId xmlns:a16="http://schemas.microsoft.com/office/drawing/2014/main" id="{F7ACB026-12F4-3EBD-4622-0E7C94B068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71033" y="1919388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2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08D30170-D9FF-DBC6-EBF9-1C1E1C7A1AB7}"/>
              </a:ext>
            </a:extLst>
          </p:cNvPr>
          <p:cNvSpPr txBox="1"/>
          <p:nvPr/>
        </p:nvSpPr>
        <p:spPr>
          <a:xfrm>
            <a:off x="5426649" y="2017760"/>
            <a:ext cx="8125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Specificity</a:t>
            </a: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F4DE7284-A4BE-E0AB-32BD-659EC704CD6F}"/>
              </a:ext>
            </a:extLst>
          </p:cNvPr>
          <p:cNvSpPr txBox="1"/>
          <p:nvPr/>
        </p:nvSpPr>
        <p:spPr>
          <a:xfrm>
            <a:off x="5101562" y="365653"/>
            <a:ext cx="13161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Body weight (kg)</a:t>
            </a:r>
          </a:p>
        </p:txBody>
      </p:sp>
      <p:sp>
        <p:nvSpPr>
          <p:cNvPr id="46" name="正方形/長方形 45">
            <a:extLst>
              <a:ext uri="{FF2B5EF4-FFF2-40B4-BE49-F238E27FC236}">
                <a16:creationId xmlns:a16="http://schemas.microsoft.com/office/drawing/2014/main" id="{DF539AD8-1D6E-1CC9-045A-65FC53EBA9BF}"/>
              </a:ext>
            </a:extLst>
          </p:cNvPr>
          <p:cNvSpPr/>
          <p:nvPr/>
        </p:nvSpPr>
        <p:spPr>
          <a:xfrm flipV="1">
            <a:off x="5679627" y="1168745"/>
            <a:ext cx="386528" cy="457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47" name="円/楕円 22">
            <a:extLst>
              <a:ext uri="{FF2B5EF4-FFF2-40B4-BE49-F238E27FC236}">
                <a16:creationId xmlns:a16="http://schemas.microsoft.com/office/drawing/2014/main" id="{D3F40312-EA23-871D-302E-43F35C710257}"/>
              </a:ext>
            </a:extLst>
          </p:cNvPr>
          <p:cNvSpPr/>
          <p:nvPr/>
        </p:nvSpPr>
        <p:spPr>
          <a:xfrm>
            <a:off x="5652599" y="1147890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48" name="Rectangle 74">
            <a:extLst>
              <a:ext uri="{FF2B5EF4-FFF2-40B4-BE49-F238E27FC236}">
                <a16:creationId xmlns:a16="http://schemas.microsoft.com/office/drawing/2014/main" id="{D77FC091-3864-3C35-74D8-8A92ED4884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60681" y="1147890"/>
            <a:ext cx="22442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61kg</a:t>
            </a:r>
            <a:endParaRPr kumimoji="0" lang="ja-JP" altLang="ja-JP" sz="800" b="0" i="0" u="none" strike="noStrike" cap="none" normalizeH="0" baseline="3000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3D2AAA83-A658-A338-5DA2-33BC0A4A2055}"/>
              </a:ext>
            </a:extLst>
          </p:cNvPr>
          <p:cNvSpPr/>
          <p:nvPr/>
        </p:nvSpPr>
        <p:spPr>
          <a:xfrm>
            <a:off x="283617" y="355779"/>
            <a:ext cx="220840" cy="176701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10" name="Rectangle 74">
            <a:extLst>
              <a:ext uri="{FF2B5EF4-FFF2-40B4-BE49-F238E27FC236}">
                <a16:creationId xmlns:a16="http://schemas.microsoft.com/office/drawing/2014/main" id="{846E1193-C891-90DF-38CB-7EEA1B09AA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0187" y="545562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1.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11" name="Rectangle 74">
            <a:extLst>
              <a:ext uri="{FF2B5EF4-FFF2-40B4-BE49-F238E27FC236}">
                <a16:creationId xmlns:a16="http://schemas.microsoft.com/office/drawing/2014/main" id="{FB435E45-5BCC-287E-C4D9-3E084438A7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0187" y="1040430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6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12" name="Rectangle 74">
            <a:extLst>
              <a:ext uri="{FF2B5EF4-FFF2-40B4-BE49-F238E27FC236}">
                <a16:creationId xmlns:a16="http://schemas.microsoft.com/office/drawing/2014/main" id="{FC1A933B-112A-0A96-E7B3-56D1EEEF44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0187" y="1287864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4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13" name="Rectangle 74">
            <a:extLst>
              <a:ext uri="{FF2B5EF4-FFF2-40B4-BE49-F238E27FC236}">
                <a16:creationId xmlns:a16="http://schemas.microsoft.com/office/drawing/2014/main" id="{4CF33841-15D3-8F41-BC2C-C14CC0A20E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5880" y="1782730"/>
            <a:ext cx="57708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14" name="Rectangle 74">
            <a:extLst>
              <a:ext uri="{FF2B5EF4-FFF2-40B4-BE49-F238E27FC236}">
                <a16:creationId xmlns:a16="http://schemas.microsoft.com/office/drawing/2014/main" id="{9B030D15-FAA7-51AA-B0C1-6EBD68E1EA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0187" y="792996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8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15" name="Rectangle 74">
            <a:extLst>
              <a:ext uri="{FF2B5EF4-FFF2-40B4-BE49-F238E27FC236}">
                <a16:creationId xmlns:a16="http://schemas.microsoft.com/office/drawing/2014/main" id="{9B240EE6-4546-3B17-C30B-F212917B60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0187" y="1535298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2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81D5B73-35A3-FD85-27A2-C06E5869DC9F}"/>
              </a:ext>
            </a:extLst>
          </p:cNvPr>
          <p:cNvSpPr txBox="1"/>
          <p:nvPr/>
        </p:nvSpPr>
        <p:spPr>
          <a:xfrm rot="16200000">
            <a:off x="-125854" y="1111136"/>
            <a:ext cx="755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Sensitivity</a:t>
            </a: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70A9083F-0B8A-D1E7-73B7-6BC7C4E99C9E}"/>
              </a:ext>
            </a:extLst>
          </p:cNvPr>
          <p:cNvSpPr/>
          <p:nvPr/>
        </p:nvSpPr>
        <p:spPr>
          <a:xfrm>
            <a:off x="529170" y="1925099"/>
            <a:ext cx="1362044" cy="1774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18" name="Rectangle 74">
            <a:extLst>
              <a:ext uri="{FF2B5EF4-FFF2-40B4-BE49-F238E27FC236}">
                <a16:creationId xmlns:a16="http://schemas.microsoft.com/office/drawing/2014/main" id="{0CA73BEB-DF8B-3F38-C007-4AAB044750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5267" y="1919388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1.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20" name="Rectangle 74">
            <a:extLst>
              <a:ext uri="{FF2B5EF4-FFF2-40B4-BE49-F238E27FC236}">
                <a16:creationId xmlns:a16="http://schemas.microsoft.com/office/drawing/2014/main" id="{1CD5942D-0A39-F5BF-1B76-E8BA06344A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03865" y="1919388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6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21" name="Rectangle 74">
            <a:extLst>
              <a:ext uri="{FF2B5EF4-FFF2-40B4-BE49-F238E27FC236}">
                <a16:creationId xmlns:a16="http://schemas.microsoft.com/office/drawing/2014/main" id="{62BAB618-A695-11DA-B9E0-97E9A552ED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60520" y="1919388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4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22" name="Rectangle 74">
            <a:extLst>
              <a:ext uri="{FF2B5EF4-FFF2-40B4-BE49-F238E27FC236}">
                <a16:creationId xmlns:a16="http://schemas.microsoft.com/office/drawing/2014/main" id="{498AB43E-6C26-F3E8-F858-1076A7C3CF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98544" y="1919388"/>
            <a:ext cx="57708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23" name="Rectangle 74">
            <a:extLst>
              <a:ext uri="{FF2B5EF4-FFF2-40B4-BE49-F238E27FC236}">
                <a16:creationId xmlns:a16="http://schemas.microsoft.com/office/drawing/2014/main" id="{7857DB65-053B-2CE3-748D-E50AEB015C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1922" y="1919388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8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24" name="Rectangle 74">
            <a:extLst>
              <a:ext uri="{FF2B5EF4-FFF2-40B4-BE49-F238E27FC236}">
                <a16:creationId xmlns:a16="http://schemas.microsoft.com/office/drawing/2014/main" id="{A3310BA2-2523-3D4D-6F49-FC0D3983EB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8641" y="1919388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2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B06B3696-A9EF-8552-1D50-B1FA6D7957E6}"/>
              </a:ext>
            </a:extLst>
          </p:cNvPr>
          <p:cNvSpPr txBox="1"/>
          <p:nvPr/>
        </p:nvSpPr>
        <p:spPr>
          <a:xfrm>
            <a:off x="854257" y="2017760"/>
            <a:ext cx="8125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Specificity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B984C801-0A7D-1196-15A1-F97C994C7E86}"/>
              </a:ext>
            </a:extLst>
          </p:cNvPr>
          <p:cNvSpPr txBox="1"/>
          <p:nvPr/>
        </p:nvSpPr>
        <p:spPr>
          <a:xfrm>
            <a:off x="529170" y="365653"/>
            <a:ext cx="13161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Eosinophils (%)</a:t>
            </a:r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455F7B6C-F0CA-D608-4F60-7418B98C458B}"/>
              </a:ext>
            </a:extLst>
          </p:cNvPr>
          <p:cNvSpPr/>
          <p:nvPr/>
        </p:nvSpPr>
        <p:spPr>
          <a:xfrm flipV="1">
            <a:off x="1120195" y="730004"/>
            <a:ext cx="379559" cy="36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28" name="円/楕円 22">
            <a:extLst>
              <a:ext uri="{FF2B5EF4-FFF2-40B4-BE49-F238E27FC236}">
                <a16:creationId xmlns:a16="http://schemas.microsoft.com/office/drawing/2014/main" id="{89CB9E7D-6398-044D-E7FA-697168779B86}"/>
              </a:ext>
            </a:extLst>
          </p:cNvPr>
          <p:cNvSpPr/>
          <p:nvPr/>
        </p:nvSpPr>
        <p:spPr>
          <a:xfrm>
            <a:off x="1087703" y="708087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49" name="Rectangle 74">
            <a:extLst>
              <a:ext uri="{FF2B5EF4-FFF2-40B4-BE49-F238E27FC236}">
                <a16:creationId xmlns:a16="http://schemas.microsoft.com/office/drawing/2014/main" id="{D57734F7-76F7-CFFA-88C1-95F5F1EB9E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9610" y="647599"/>
            <a:ext cx="235642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1.8%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51" name="正方形/長方形 50">
            <a:extLst>
              <a:ext uri="{FF2B5EF4-FFF2-40B4-BE49-F238E27FC236}">
                <a16:creationId xmlns:a16="http://schemas.microsoft.com/office/drawing/2014/main" id="{63968FF7-E11B-6F5E-3B18-761DE6E4D5DF}"/>
              </a:ext>
            </a:extLst>
          </p:cNvPr>
          <p:cNvSpPr/>
          <p:nvPr/>
        </p:nvSpPr>
        <p:spPr>
          <a:xfrm>
            <a:off x="2483537" y="351693"/>
            <a:ext cx="220840" cy="176701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52" name="Rectangle 74">
            <a:extLst>
              <a:ext uri="{FF2B5EF4-FFF2-40B4-BE49-F238E27FC236}">
                <a16:creationId xmlns:a16="http://schemas.microsoft.com/office/drawing/2014/main" id="{BBC9DDFE-8C49-3E1E-7B06-7E832D25AB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0107" y="541476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1.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53" name="Rectangle 74">
            <a:extLst>
              <a:ext uri="{FF2B5EF4-FFF2-40B4-BE49-F238E27FC236}">
                <a16:creationId xmlns:a16="http://schemas.microsoft.com/office/drawing/2014/main" id="{8DCF54AB-C8D3-AAE3-D297-82F9EF088E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0107" y="1036344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6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54" name="Rectangle 74">
            <a:extLst>
              <a:ext uri="{FF2B5EF4-FFF2-40B4-BE49-F238E27FC236}">
                <a16:creationId xmlns:a16="http://schemas.microsoft.com/office/drawing/2014/main" id="{F09C61BD-EDA4-788A-18F9-29C64F48F2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0107" y="1283778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4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55" name="Rectangle 74">
            <a:extLst>
              <a:ext uri="{FF2B5EF4-FFF2-40B4-BE49-F238E27FC236}">
                <a16:creationId xmlns:a16="http://schemas.microsoft.com/office/drawing/2014/main" id="{374DCBEE-677C-CC4F-F002-B3CF1346F9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55800" y="1778644"/>
            <a:ext cx="57708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56" name="Rectangle 74">
            <a:extLst>
              <a:ext uri="{FF2B5EF4-FFF2-40B4-BE49-F238E27FC236}">
                <a16:creationId xmlns:a16="http://schemas.microsoft.com/office/drawing/2014/main" id="{029ACE68-BE91-1BC9-F0E9-B2EB3B60B2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0107" y="788910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8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57" name="Rectangle 74">
            <a:extLst>
              <a:ext uri="{FF2B5EF4-FFF2-40B4-BE49-F238E27FC236}">
                <a16:creationId xmlns:a16="http://schemas.microsoft.com/office/drawing/2014/main" id="{C7BF7616-A81F-F45B-3BF8-E7083C5D77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0107" y="1531212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2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69E95AD8-1633-CD66-A50F-73B5EE87C500}"/>
              </a:ext>
            </a:extLst>
          </p:cNvPr>
          <p:cNvSpPr txBox="1"/>
          <p:nvPr/>
        </p:nvSpPr>
        <p:spPr>
          <a:xfrm rot="16200000">
            <a:off x="2063580" y="1102233"/>
            <a:ext cx="755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Sensitivity</a:t>
            </a:r>
          </a:p>
        </p:txBody>
      </p:sp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F60FCFD6-B891-D205-6595-21FC1B7C6A2A}"/>
              </a:ext>
            </a:extLst>
          </p:cNvPr>
          <p:cNvSpPr/>
          <p:nvPr/>
        </p:nvSpPr>
        <p:spPr>
          <a:xfrm>
            <a:off x="2729090" y="1921013"/>
            <a:ext cx="1362044" cy="1774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60" name="Rectangle 74">
            <a:extLst>
              <a:ext uri="{FF2B5EF4-FFF2-40B4-BE49-F238E27FC236}">
                <a16:creationId xmlns:a16="http://schemas.microsoft.com/office/drawing/2014/main" id="{4C5A30D7-AEB9-8772-5AC7-DE25284328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15187" y="1915302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1.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61" name="Rectangle 74">
            <a:extLst>
              <a:ext uri="{FF2B5EF4-FFF2-40B4-BE49-F238E27FC236}">
                <a16:creationId xmlns:a16="http://schemas.microsoft.com/office/drawing/2014/main" id="{5B547F9E-6D45-8D43-361F-C96703CDE1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03785" y="1915302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6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62" name="Rectangle 74">
            <a:extLst>
              <a:ext uri="{FF2B5EF4-FFF2-40B4-BE49-F238E27FC236}">
                <a16:creationId xmlns:a16="http://schemas.microsoft.com/office/drawing/2014/main" id="{85F4AF41-66D6-810E-8191-41AC3E5723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60440" y="1915302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4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63" name="Rectangle 74">
            <a:extLst>
              <a:ext uri="{FF2B5EF4-FFF2-40B4-BE49-F238E27FC236}">
                <a16:creationId xmlns:a16="http://schemas.microsoft.com/office/drawing/2014/main" id="{1A0BA27A-D8C8-E36C-504E-46BFDDC2E4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98464" y="1915302"/>
            <a:ext cx="57708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64" name="Rectangle 74">
            <a:extLst>
              <a:ext uri="{FF2B5EF4-FFF2-40B4-BE49-F238E27FC236}">
                <a16:creationId xmlns:a16="http://schemas.microsoft.com/office/drawing/2014/main" id="{609860F5-3789-BF0F-B379-CBEAA2826D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71842" y="1915302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8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65" name="Rectangle 74">
            <a:extLst>
              <a:ext uri="{FF2B5EF4-FFF2-40B4-BE49-F238E27FC236}">
                <a16:creationId xmlns:a16="http://schemas.microsoft.com/office/drawing/2014/main" id="{7640C86E-3702-B96F-5C37-BA90B1ADB9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98561" y="1915302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2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7A8AB9C8-9CC3-E260-B023-6DEF07B9F939}"/>
              </a:ext>
            </a:extLst>
          </p:cNvPr>
          <p:cNvSpPr txBox="1"/>
          <p:nvPr/>
        </p:nvSpPr>
        <p:spPr>
          <a:xfrm>
            <a:off x="3054177" y="2013674"/>
            <a:ext cx="8125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Specificity</a:t>
            </a: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973FD81E-93BA-E926-34A2-0DC9F54B2C89}"/>
              </a:ext>
            </a:extLst>
          </p:cNvPr>
          <p:cNvSpPr txBox="1"/>
          <p:nvPr/>
        </p:nvSpPr>
        <p:spPr>
          <a:xfrm>
            <a:off x="2729090" y="361567"/>
            <a:ext cx="14832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Eosinophil count </a:t>
            </a:r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(/</a:t>
            </a:r>
            <a:r>
              <a:rPr lang="el-GR" altLang="ja-JP" sz="800" dirty="0">
                <a:latin typeface="Arial" charset="0"/>
                <a:ea typeface="Arial" charset="0"/>
                <a:cs typeface="Arial" charset="0"/>
              </a:rPr>
              <a:t>μ</a:t>
            </a:r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L)</a:t>
            </a:r>
            <a:endParaRPr kumimoji="1" lang="en-US" altLang="ja-JP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2829939-BF3D-CB44-8AA3-3566AE5E6C3E}"/>
              </a:ext>
            </a:extLst>
          </p:cNvPr>
          <p:cNvSpPr txBox="1"/>
          <p:nvPr/>
        </p:nvSpPr>
        <p:spPr>
          <a:xfrm>
            <a:off x="64304" y="2613010"/>
            <a:ext cx="4068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Arial" charset="0"/>
                <a:ea typeface="Arial" charset="0"/>
                <a:cs typeface="Arial" charset="0"/>
              </a:rPr>
              <a:t>D</a:t>
            </a:r>
            <a:endParaRPr kumimoji="1" lang="ja-JP" alt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74BB01F7-7DC9-5B23-E091-D7DED2525A2E}"/>
              </a:ext>
            </a:extLst>
          </p:cNvPr>
          <p:cNvSpPr/>
          <p:nvPr/>
        </p:nvSpPr>
        <p:spPr>
          <a:xfrm>
            <a:off x="319260" y="2688719"/>
            <a:ext cx="220840" cy="176701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19" name="Rectangle 74">
            <a:extLst>
              <a:ext uri="{FF2B5EF4-FFF2-40B4-BE49-F238E27FC236}">
                <a16:creationId xmlns:a16="http://schemas.microsoft.com/office/drawing/2014/main" id="{801CD93B-180C-55D3-848C-B7D815F357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5830" y="2878502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1.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50" name="Rectangle 74">
            <a:extLst>
              <a:ext uri="{FF2B5EF4-FFF2-40B4-BE49-F238E27FC236}">
                <a16:creationId xmlns:a16="http://schemas.microsoft.com/office/drawing/2014/main" id="{F0D6F560-DA1E-C18A-BF7D-4FDB5A9A1D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5830" y="3373370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6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72" name="Rectangle 74">
            <a:extLst>
              <a:ext uri="{FF2B5EF4-FFF2-40B4-BE49-F238E27FC236}">
                <a16:creationId xmlns:a16="http://schemas.microsoft.com/office/drawing/2014/main" id="{B1D73232-AB5D-FEE2-90A1-14FCF36EE7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5830" y="3620804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4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74" name="Rectangle 74">
            <a:extLst>
              <a:ext uri="{FF2B5EF4-FFF2-40B4-BE49-F238E27FC236}">
                <a16:creationId xmlns:a16="http://schemas.microsoft.com/office/drawing/2014/main" id="{8C095916-A38A-EBC5-0E9B-1668DA3380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1523" y="4115670"/>
            <a:ext cx="57708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06A4BC65-ED10-4EF2-7810-BE682E0760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5830" y="3125936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8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76" name="Rectangle 74">
            <a:extLst>
              <a:ext uri="{FF2B5EF4-FFF2-40B4-BE49-F238E27FC236}">
                <a16:creationId xmlns:a16="http://schemas.microsoft.com/office/drawing/2014/main" id="{765FB694-E4E1-F1D4-ECE7-632346DABC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5830" y="3868238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2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5D742B4A-8601-98CF-DD1E-F1325B048C70}"/>
              </a:ext>
            </a:extLst>
          </p:cNvPr>
          <p:cNvSpPr txBox="1"/>
          <p:nvPr/>
        </p:nvSpPr>
        <p:spPr>
          <a:xfrm rot="16200000">
            <a:off x="-90211" y="3444076"/>
            <a:ext cx="755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Sensitivity</a:t>
            </a:r>
          </a:p>
        </p:txBody>
      </p:sp>
      <p:sp>
        <p:nvSpPr>
          <p:cNvPr id="78" name="正方形/長方形 77">
            <a:extLst>
              <a:ext uri="{FF2B5EF4-FFF2-40B4-BE49-F238E27FC236}">
                <a16:creationId xmlns:a16="http://schemas.microsoft.com/office/drawing/2014/main" id="{EE0CDF5F-07E2-52FC-ED73-0C286E9CB4FC}"/>
              </a:ext>
            </a:extLst>
          </p:cNvPr>
          <p:cNvSpPr/>
          <p:nvPr/>
        </p:nvSpPr>
        <p:spPr>
          <a:xfrm>
            <a:off x="564813" y="4258039"/>
            <a:ext cx="1362044" cy="1774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79" name="Rectangle 74">
            <a:extLst>
              <a:ext uri="{FF2B5EF4-FFF2-40B4-BE49-F238E27FC236}">
                <a16:creationId xmlns:a16="http://schemas.microsoft.com/office/drawing/2014/main" id="{C1FC10E3-EB4B-C898-5A21-C93658EAB0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0910" y="4252328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1.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80" name="Rectangle 74">
            <a:extLst>
              <a:ext uri="{FF2B5EF4-FFF2-40B4-BE49-F238E27FC236}">
                <a16:creationId xmlns:a16="http://schemas.microsoft.com/office/drawing/2014/main" id="{6C078EE7-E6D3-EFA9-B73D-90164ABD6B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39508" y="4252328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6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81" name="Rectangle 74">
            <a:extLst>
              <a:ext uri="{FF2B5EF4-FFF2-40B4-BE49-F238E27FC236}">
                <a16:creationId xmlns:a16="http://schemas.microsoft.com/office/drawing/2014/main" id="{4FBC8DBC-2AA1-9AB5-241A-9C87AB86B1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96163" y="4252328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4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82" name="Rectangle 74">
            <a:extLst>
              <a:ext uri="{FF2B5EF4-FFF2-40B4-BE49-F238E27FC236}">
                <a16:creationId xmlns:a16="http://schemas.microsoft.com/office/drawing/2014/main" id="{32B9BAC4-A002-65AB-3C28-34965A6868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34187" y="4252328"/>
            <a:ext cx="57708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83" name="Rectangle 74">
            <a:extLst>
              <a:ext uri="{FF2B5EF4-FFF2-40B4-BE49-F238E27FC236}">
                <a16:creationId xmlns:a16="http://schemas.microsoft.com/office/drawing/2014/main" id="{605F5257-8578-F9B5-B86F-C21529C663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7565" y="4252328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8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84" name="Rectangle 74">
            <a:extLst>
              <a:ext uri="{FF2B5EF4-FFF2-40B4-BE49-F238E27FC236}">
                <a16:creationId xmlns:a16="http://schemas.microsoft.com/office/drawing/2014/main" id="{B667B698-E242-30EA-6C9C-AF24E74AC2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34284" y="4252328"/>
            <a:ext cx="144270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0.2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B92AE8FE-00C3-7698-F629-E3BE862CEF8F}"/>
              </a:ext>
            </a:extLst>
          </p:cNvPr>
          <p:cNvSpPr txBox="1"/>
          <p:nvPr/>
        </p:nvSpPr>
        <p:spPr>
          <a:xfrm>
            <a:off x="889900" y="4350700"/>
            <a:ext cx="8125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Specificity</a:t>
            </a: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357F9B1D-0EE6-E0C8-5244-10C0CFFE40AC}"/>
              </a:ext>
            </a:extLst>
          </p:cNvPr>
          <p:cNvSpPr txBox="1"/>
          <p:nvPr/>
        </p:nvSpPr>
        <p:spPr>
          <a:xfrm>
            <a:off x="564813" y="2698593"/>
            <a:ext cx="13161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Body surface area (m</a:t>
            </a:r>
            <a:r>
              <a:rPr kumimoji="1" lang="en-US" altLang="ja-JP" sz="800" baseline="30000" dirty="0">
                <a:latin typeface="Arial" charset="0"/>
                <a:ea typeface="Arial" charset="0"/>
                <a:cs typeface="Arial" charset="0"/>
              </a:rPr>
              <a:t>2</a:t>
            </a:r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)</a:t>
            </a:r>
          </a:p>
        </p:txBody>
      </p:sp>
      <p:sp>
        <p:nvSpPr>
          <p:cNvPr id="87" name="正方形/長方形 86">
            <a:extLst>
              <a:ext uri="{FF2B5EF4-FFF2-40B4-BE49-F238E27FC236}">
                <a16:creationId xmlns:a16="http://schemas.microsoft.com/office/drawing/2014/main" id="{F69A2A5C-A9D6-61D5-7F90-19A08D8369A1}"/>
              </a:ext>
            </a:extLst>
          </p:cNvPr>
          <p:cNvSpPr/>
          <p:nvPr/>
        </p:nvSpPr>
        <p:spPr>
          <a:xfrm flipV="1">
            <a:off x="1260519" y="3363200"/>
            <a:ext cx="343913" cy="5591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88" name="円/楕円 22">
            <a:extLst>
              <a:ext uri="{FF2B5EF4-FFF2-40B4-BE49-F238E27FC236}">
                <a16:creationId xmlns:a16="http://schemas.microsoft.com/office/drawing/2014/main" id="{F710B6EB-6195-507D-F1AF-6C7C8607872A}"/>
              </a:ext>
            </a:extLst>
          </p:cNvPr>
          <p:cNvSpPr/>
          <p:nvPr/>
        </p:nvSpPr>
        <p:spPr>
          <a:xfrm>
            <a:off x="1225865" y="3333137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89" name="Rectangle 74">
            <a:extLst>
              <a:ext uri="{FF2B5EF4-FFF2-40B4-BE49-F238E27FC236}">
                <a16:creationId xmlns:a16="http://schemas.microsoft.com/office/drawing/2014/main" id="{6BFADA7A-D66F-3674-DAB1-6F5109E16D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59793" y="3361791"/>
            <a:ext cx="383118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800" dirty="0"/>
              <a:t>1.633m</a:t>
            </a:r>
            <a:r>
              <a:rPr kumimoji="0" lang="en-US" altLang="ja-JP" sz="800" baseline="30000" dirty="0"/>
              <a:t>2</a:t>
            </a:r>
            <a:endParaRPr kumimoji="0" lang="ja-JP" altLang="ja-JP" sz="800" b="0" i="0" u="none" strike="noStrike" cap="none" normalizeH="0" baseline="3000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92" name="正方形/長方形 91">
            <a:extLst>
              <a:ext uri="{FF2B5EF4-FFF2-40B4-BE49-F238E27FC236}">
                <a16:creationId xmlns:a16="http://schemas.microsoft.com/office/drawing/2014/main" id="{99886799-8555-AF37-057B-133EE19D7317}"/>
              </a:ext>
            </a:extLst>
          </p:cNvPr>
          <p:cNvSpPr/>
          <p:nvPr/>
        </p:nvSpPr>
        <p:spPr>
          <a:xfrm flipV="1">
            <a:off x="3088848" y="1035276"/>
            <a:ext cx="379559" cy="36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93" name="円/楕円 22">
            <a:extLst>
              <a:ext uri="{FF2B5EF4-FFF2-40B4-BE49-F238E27FC236}">
                <a16:creationId xmlns:a16="http://schemas.microsoft.com/office/drawing/2014/main" id="{9E9DDC6A-C2F4-35FE-6B1E-754EC5847C09}"/>
              </a:ext>
            </a:extLst>
          </p:cNvPr>
          <p:cNvSpPr/>
          <p:nvPr/>
        </p:nvSpPr>
        <p:spPr>
          <a:xfrm>
            <a:off x="3052123" y="1000660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94" name="Rectangle 74">
            <a:extLst>
              <a:ext uri="{FF2B5EF4-FFF2-40B4-BE49-F238E27FC236}">
                <a16:creationId xmlns:a16="http://schemas.microsoft.com/office/drawing/2014/main" id="{F3BC257C-74EA-D9D3-07F7-6247D79926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58195" y="941521"/>
            <a:ext cx="173124" cy="123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en-US" altLang="ja-JP" sz="800" dirty="0"/>
              <a:t>200</a:t>
            </a:r>
            <a:endParaRPr kumimoji="0" lang="ja-JP" altLang="ja-JP" sz="8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1CB8BEDF-6648-CB2E-883A-ECFA2AD29AB2}"/>
              </a:ext>
            </a:extLst>
          </p:cNvPr>
          <p:cNvSpPr txBox="1"/>
          <p:nvPr/>
        </p:nvSpPr>
        <p:spPr>
          <a:xfrm>
            <a:off x="180062" y="5041928"/>
            <a:ext cx="667793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(A-D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eiver-operating characteristic curve analysis of th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osinophil proportion,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osinophil count,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ody weight, and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ody surface area associated with the occurrence of skin-related adverse events of any grade.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2825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068</TotalTime>
  <Words>189</Words>
  <Application>Microsoft Office PowerPoint</Application>
  <PresentationFormat>A4 210 x 297 mm</PresentationFormat>
  <Paragraphs>7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州広 小田切</dc:creator>
  <cp:lastModifiedBy>薬剤部共用PC20 名古屋市立大学病院</cp:lastModifiedBy>
  <cp:revision>55</cp:revision>
  <cp:lastPrinted>2024-12-13T07:03:54Z</cp:lastPrinted>
  <dcterms:created xsi:type="dcterms:W3CDTF">2024-11-30T06:30:13Z</dcterms:created>
  <dcterms:modified xsi:type="dcterms:W3CDTF">2025-09-26T01:43:19Z</dcterms:modified>
</cp:coreProperties>
</file>